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298" r:id="rId5"/>
  </p:sldIdLst>
  <p:sldSz cx="6858000" cy="9906000" type="A4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CC9900"/>
    <a:srgbClr val="FFCC00"/>
    <a:srgbClr val="FFFFFF"/>
    <a:srgbClr val="E8B7B7"/>
    <a:srgbClr val="A8CDD7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5161" autoAdjust="0"/>
  </p:normalViewPr>
  <p:slideViewPr>
    <p:cSldViewPr snapToGrid="0">
      <p:cViewPr varScale="1">
        <p:scale>
          <a:sx n="71" d="100"/>
          <a:sy n="71" d="100"/>
        </p:scale>
        <p:origin x="144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 Weis" userId="6a51f4e6-0e93-4a18-834c-a49e1ed77407" providerId="ADAL" clId="{6959E033-7E6A-4EA0-AB19-75F676599088}"/>
    <pc:docChg chg="undo custSel addSld modSld">
      <pc:chgData name="Sara Weis" userId="6a51f4e6-0e93-4a18-834c-a49e1ed77407" providerId="ADAL" clId="{6959E033-7E6A-4EA0-AB19-75F676599088}" dt="2025-01-02T17:18:45.578" v="422" actId="1076"/>
      <pc:docMkLst>
        <pc:docMk/>
      </pc:docMkLst>
      <pc:sldChg chg="addSp delSp modSp">
        <pc:chgData name="Sara Weis" userId="6a51f4e6-0e93-4a18-834c-a49e1ed77407" providerId="ADAL" clId="{6959E033-7E6A-4EA0-AB19-75F676599088}" dt="2025-01-02T17:15:24.765" v="382" actId="20577"/>
        <pc:sldMkLst>
          <pc:docMk/>
          <pc:sldMk cId="2106248321" sldId="298"/>
        </pc:sldMkLst>
        <pc:spChg chg="add mod">
          <ac:chgData name="Sara Weis" userId="6a51f4e6-0e93-4a18-834c-a49e1ed77407" providerId="ADAL" clId="{6959E033-7E6A-4EA0-AB19-75F676599088}" dt="2025-01-02T17:15:24.765" v="382" actId="20577"/>
          <ac:spMkLst>
            <pc:docMk/>
            <pc:sldMk cId="2106248321" sldId="298"/>
            <ac:spMk id="3" creationId="{F85F01AF-E2FC-4A20-BC96-820C3267DBD5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9" creationId="{75936999-04B7-4CA0-96C9-CD97C06BD1F1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10" creationId="{98561D18-56B5-4A22-B657-19C0C43B029A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11" creationId="{06F6387F-5DC2-44EE-B710-A3F4811AD05E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12" creationId="{B599E299-20AD-4B90-863E-C9F21A3FC407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19" creationId="{236DD729-0233-4845-B1E1-FF2549A9C872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20" creationId="{87F2151C-91AE-444F-BA0A-F5DE6A8495AA}"/>
          </ac:spMkLst>
        </pc:spChg>
        <pc:spChg chg="mod">
          <ac:chgData name="Sara Weis" userId="6a51f4e6-0e93-4a18-834c-a49e1ed77407" providerId="ADAL" clId="{6959E033-7E6A-4EA0-AB19-75F676599088}" dt="2025-01-02T17:08:03.483" v="375" actId="1076"/>
          <ac:spMkLst>
            <pc:docMk/>
            <pc:sldMk cId="2106248321" sldId="298"/>
            <ac:spMk id="23" creationId="{9837469B-6902-495A-86E3-722D7C6A57DC}"/>
          </ac:spMkLst>
        </pc:spChg>
        <pc:spChg chg="del">
          <ac:chgData name="Sara Weis" userId="6a51f4e6-0e93-4a18-834c-a49e1ed77407" providerId="ADAL" clId="{6959E033-7E6A-4EA0-AB19-75F676599088}" dt="2025-01-02T17:05:57.477" v="359" actId="478"/>
          <ac:spMkLst>
            <pc:docMk/>
            <pc:sldMk cId="2106248321" sldId="298"/>
            <ac:spMk id="45" creationId="{F3A9156C-C54C-4614-ABB9-5AF095F0F775}"/>
          </ac:spMkLst>
        </pc:spChg>
        <pc:spChg chg="mod">
          <ac:chgData name="Sara Weis" userId="6a51f4e6-0e93-4a18-834c-a49e1ed77407" providerId="ADAL" clId="{6959E033-7E6A-4EA0-AB19-75F676599088}" dt="2025-01-02T16:57:01.182" v="68" actId="1076"/>
          <ac:spMkLst>
            <pc:docMk/>
            <pc:sldMk cId="2106248321" sldId="298"/>
            <ac:spMk id="56" creationId="{1CE285CC-DC0D-4825-9EDF-E3D5D8427719}"/>
          </ac:spMkLst>
        </pc:spChg>
        <pc:spChg chg="mod">
          <ac:chgData name="Sara Weis" userId="6a51f4e6-0e93-4a18-834c-a49e1ed77407" providerId="ADAL" clId="{6959E033-7E6A-4EA0-AB19-75F676599088}" dt="2025-01-02T17:08:03.483" v="375" actId="1076"/>
          <ac:spMkLst>
            <pc:docMk/>
            <pc:sldMk cId="2106248321" sldId="298"/>
            <ac:spMk id="70" creationId="{7A30D47F-4FE9-4840-9977-6022DD4A371A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76" creationId="{3F6D0F30-184D-40C5-AF9D-82030B65FD09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77" creationId="{8CB2C145-4003-477F-81BA-EEA2846A0D4F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78" creationId="{5B67D640-44A5-4C40-8143-D52616D97BD9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84" creationId="{B5744F81-4DF0-4530-87BD-B543F756DD8F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85" creationId="{D04BE4A0-467D-4070-B64B-9F2C118EF847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86" creationId="{98515101-AB5F-4E78-A682-FFAEA0B99110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88" creationId="{5C118BE6-EAB6-49A0-8589-3C1535D4CA55}"/>
          </ac:spMkLst>
        </pc:spChg>
        <pc:spChg chg="mod">
          <ac:chgData name="Sara Weis" userId="6a51f4e6-0e93-4a18-834c-a49e1ed77407" providerId="ADAL" clId="{6959E033-7E6A-4EA0-AB19-75F676599088}" dt="2025-01-02T16:57:10.910" v="87" actId="1035"/>
          <ac:spMkLst>
            <pc:docMk/>
            <pc:sldMk cId="2106248321" sldId="298"/>
            <ac:spMk id="94" creationId="{2650BDE5-AD2F-42F9-A372-1968EC006B7E}"/>
          </ac:spMkLst>
        </pc:spChg>
        <pc:grpChg chg="add mod">
          <ac:chgData name="Sara Weis" userId="6a51f4e6-0e93-4a18-834c-a49e1ed77407" providerId="ADAL" clId="{6959E033-7E6A-4EA0-AB19-75F676599088}" dt="2025-01-02T17:08:09.193" v="377" actId="14100"/>
          <ac:grpSpMkLst>
            <pc:docMk/>
            <pc:sldMk cId="2106248321" sldId="298"/>
            <ac:grpSpMk id="2" creationId="{960064E3-9BEA-4925-8610-BCA826CE0C41}"/>
          </ac:grpSpMkLst>
        </pc:grpChg>
        <pc:grpChg chg="mod">
          <ac:chgData name="Sara Weis" userId="6a51f4e6-0e93-4a18-834c-a49e1ed77407" providerId="ADAL" clId="{6959E033-7E6A-4EA0-AB19-75F676599088}" dt="2025-01-02T16:56:35.670" v="63" actId="164"/>
          <ac:grpSpMkLst>
            <pc:docMk/>
            <pc:sldMk cId="2106248321" sldId="298"/>
            <ac:grpSpMk id="18" creationId="{6C3C0227-C401-42B7-83D7-5BCA28C7679E}"/>
          </ac:grpSpMkLst>
        </pc:grpChg>
        <pc:grpChg chg="mod">
          <ac:chgData name="Sara Weis" userId="6a51f4e6-0e93-4a18-834c-a49e1ed77407" providerId="ADAL" clId="{6959E033-7E6A-4EA0-AB19-75F676599088}" dt="2025-01-02T16:56:35.670" v="63" actId="164"/>
          <ac:grpSpMkLst>
            <pc:docMk/>
            <pc:sldMk cId="2106248321" sldId="298"/>
            <ac:grpSpMk id="24" creationId="{D5F64F85-735E-4924-B238-3BB390ADA6D2}"/>
          </ac:grpSpMkLst>
        </pc:grpChg>
        <pc:cxnChg chg="mod">
          <ac:chgData name="Sara Weis" userId="6a51f4e6-0e93-4a18-834c-a49e1ed77407" providerId="ADAL" clId="{6959E033-7E6A-4EA0-AB19-75F676599088}" dt="2025-01-02T16:56:35.670" v="63" actId="164"/>
          <ac:cxnSpMkLst>
            <pc:docMk/>
            <pc:sldMk cId="2106248321" sldId="298"/>
            <ac:cxnSpMk id="55" creationId="{444086A9-B7E4-41B3-B776-3280FA8A5349}"/>
          </ac:cxnSpMkLst>
        </pc:cxnChg>
        <pc:cxnChg chg="mod">
          <ac:chgData name="Sara Weis" userId="6a51f4e6-0e93-4a18-834c-a49e1ed77407" providerId="ADAL" clId="{6959E033-7E6A-4EA0-AB19-75F676599088}" dt="2025-01-02T16:57:10.910" v="87" actId="1035"/>
          <ac:cxnSpMkLst>
            <pc:docMk/>
            <pc:sldMk cId="2106248321" sldId="298"/>
            <ac:cxnSpMk id="93" creationId="{DBB2319C-3D95-4D00-AFE1-D23979B8E566}"/>
          </ac:cxnSpMkLst>
        </pc:cxnChg>
      </pc:sldChg>
      <pc:sldChg chg="addSp delSp modSp">
        <pc:chgData name="Sara Weis" userId="6a51f4e6-0e93-4a18-834c-a49e1ed77407" providerId="ADAL" clId="{6959E033-7E6A-4EA0-AB19-75F676599088}" dt="2025-01-02T17:18:45.578" v="422" actId="1076"/>
        <pc:sldMkLst>
          <pc:docMk/>
          <pc:sldMk cId="1407140874" sldId="309"/>
        </pc:sldMkLst>
        <pc:spChg chg="add mod">
          <ac:chgData name="Sara Weis" userId="6a51f4e6-0e93-4a18-834c-a49e1ed77407" providerId="ADAL" clId="{6959E033-7E6A-4EA0-AB19-75F676599088}" dt="2025-01-02T17:16:14.495" v="386" actId="403"/>
          <ac:spMkLst>
            <pc:docMk/>
            <pc:sldMk cId="1407140874" sldId="309"/>
            <ac:spMk id="3" creationId="{442AB1F2-5941-4F44-AC8D-E4A87AD7535C}"/>
          </ac:spMkLst>
        </pc:spChg>
        <pc:spChg chg="del">
          <ac:chgData name="Sara Weis" userId="6a51f4e6-0e93-4a18-834c-a49e1ed77407" providerId="ADAL" clId="{6959E033-7E6A-4EA0-AB19-75F676599088}" dt="2025-01-02T16:58:07.845" v="111" actId="478"/>
          <ac:spMkLst>
            <pc:docMk/>
            <pc:sldMk cId="1407140874" sldId="309"/>
            <ac:spMk id="5" creationId="{B847A6B5-FE3F-456F-A592-96E2D8DDCCD8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7" creationId="{65344804-014D-4F7F-89BE-8FDBDC89E59A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8" creationId="{08887007-58A9-4043-A9A2-D0CC96D1F9D6}"/>
          </ac:spMkLst>
        </pc:spChg>
        <pc:spChg chg="mod topLvl">
          <ac:chgData name="Sara Weis" userId="6a51f4e6-0e93-4a18-834c-a49e1ed77407" providerId="ADAL" clId="{6959E033-7E6A-4EA0-AB19-75F676599088}" dt="2025-01-02T17:18:41.401" v="421" actId="1076"/>
          <ac:spMkLst>
            <pc:docMk/>
            <pc:sldMk cId="1407140874" sldId="309"/>
            <ac:spMk id="20" creationId="{6881229C-7153-4EB2-8DAA-13FD4A567142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25" creationId="{1739EE7F-4B26-492C-9A21-D8B4D53A95D3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26" creationId="{9F8B62C0-0701-4452-9ECE-E70CF3460A27}"/>
          </ac:spMkLst>
        </pc:spChg>
        <pc:spChg chg="mod topLvl">
          <ac:chgData name="Sara Weis" userId="6a51f4e6-0e93-4a18-834c-a49e1ed77407" providerId="ADAL" clId="{6959E033-7E6A-4EA0-AB19-75F676599088}" dt="2025-01-02T17:18:41.401" v="421" actId="1076"/>
          <ac:spMkLst>
            <pc:docMk/>
            <pc:sldMk cId="1407140874" sldId="309"/>
            <ac:spMk id="27" creationId="{AFD89C10-828B-4348-9400-D3F10865C33A}"/>
          </ac:spMkLst>
        </pc:spChg>
        <pc:spChg chg="mod topLvl">
          <ac:chgData name="Sara Weis" userId="6a51f4e6-0e93-4a18-834c-a49e1ed77407" providerId="ADAL" clId="{6959E033-7E6A-4EA0-AB19-75F676599088}" dt="2025-01-02T17:18:41.401" v="421" actId="1076"/>
          <ac:spMkLst>
            <pc:docMk/>
            <pc:sldMk cId="1407140874" sldId="309"/>
            <ac:spMk id="29" creationId="{96BDDBF5-E0E9-4EDD-8442-02BF3C3A13F5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31" creationId="{7D00C1B0-C791-429C-AD61-4475D35B2BB9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32" creationId="{4B4C88B7-534D-4392-8B45-CD4DBD0E06DC}"/>
          </ac:spMkLst>
        </pc:spChg>
        <pc:spChg chg="add del mod">
          <ac:chgData name="Sara Weis" userId="6a51f4e6-0e93-4a18-834c-a49e1ed77407" providerId="ADAL" clId="{6959E033-7E6A-4EA0-AB19-75F676599088}" dt="2025-01-02T17:05:36.901" v="355" actId="478"/>
          <ac:spMkLst>
            <pc:docMk/>
            <pc:sldMk cId="1407140874" sldId="309"/>
            <ac:spMk id="36" creationId="{146899AB-8D1C-4F16-8820-601965BA1003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62" creationId="{108CAF4E-2AB6-4B17-9E6F-F1E346041C65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63" creationId="{511BFF64-48D6-483A-8213-539471607A7B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66" creationId="{B972A8FF-4AEE-45F4-8801-82D1725996E7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69" creationId="{7818342E-B8CF-47E2-93C2-646CD55FFAA5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71" creationId="{BAD48846-1FF2-41CD-B750-B8CF8ED157F2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72" creationId="{0B7EA0DE-D9AC-44F8-A250-58B0B4C4310A}"/>
          </ac:spMkLst>
        </pc:spChg>
        <pc:grpChg chg="add del mod">
          <ac:chgData name="Sara Weis" userId="6a51f4e6-0e93-4a18-834c-a49e1ed77407" providerId="ADAL" clId="{6959E033-7E6A-4EA0-AB19-75F676599088}" dt="2025-01-02T16:59:03.173" v="126" actId="165"/>
          <ac:grpSpMkLst>
            <pc:docMk/>
            <pc:sldMk cId="1407140874" sldId="309"/>
            <ac:grpSpMk id="2" creationId="{9BD144CA-C724-4B0F-B95A-C3F7FD4A5043}"/>
          </ac:grpSpMkLst>
        </pc:grpChg>
        <pc:grpChg chg="add mod">
          <ac:chgData name="Sara Weis" userId="6a51f4e6-0e93-4a18-834c-a49e1ed77407" providerId="ADAL" clId="{6959E033-7E6A-4EA0-AB19-75F676599088}" dt="2025-01-02T17:18:45.578" v="422" actId="1076"/>
          <ac:grpSpMkLst>
            <pc:docMk/>
            <pc:sldMk cId="1407140874" sldId="309"/>
            <ac:grpSpMk id="4" creationId="{EF7220AD-9458-4B13-9101-12BFA96A1810}"/>
          </ac:grpSpMkLst>
        </pc:grpChg>
        <pc:grpChg chg="mod topLvl">
          <ac:chgData name="Sara Weis" userId="6a51f4e6-0e93-4a18-834c-a49e1ed77407" providerId="ADAL" clId="{6959E033-7E6A-4EA0-AB19-75F676599088}" dt="2025-01-02T17:00:26.168" v="180" actId="164"/>
          <ac:grpSpMkLst>
            <pc:docMk/>
            <pc:sldMk cId="1407140874" sldId="309"/>
            <ac:grpSpMk id="35" creationId="{056DD648-E1CF-4B28-A93C-9EA63B3183AD}"/>
          </ac:grpSpMkLst>
        </pc:grpChg>
        <pc:grpChg chg="del mod topLvl">
          <ac:chgData name="Sara Weis" userId="6a51f4e6-0e93-4a18-834c-a49e1ed77407" providerId="ADAL" clId="{6959E033-7E6A-4EA0-AB19-75F676599088}" dt="2025-01-02T16:59:38.932" v="151" actId="165"/>
          <ac:grpSpMkLst>
            <pc:docMk/>
            <pc:sldMk cId="1407140874" sldId="309"/>
            <ac:grpSpMk id="77" creationId="{D67AE77C-DCA4-4EA9-BF3B-04475E2533A4}"/>
          </ac:grpSpMkLst>
        </pc:grp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19" creationId="{27EEF4B6-3B61-44D0-85D1-A7E062BA449C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21" creationId="{FD23F2EB-CD30-4B78-8347-E59C22718A82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45" creationId="{E5BF901F-73B1-4866-B87E-A2921145A5D4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46" creationId="{D63FE4B1-4A92-4060-97D4-2DCCFD5A0A57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47" creationId="{CC3F405E-00F9-49AE-834F-8D02BC0DEDDB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49" creationId="{D6E85C12-BFDD-4BEA-AEA9-8FB8BDDFA099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54" creationId="{96DAD91F-5FD9-4B38-8EA7-D2D986C34E88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58" creationId="{3AD79D2C-BE67-4737-BD89-A0AB15F9DDF5}"/>
          </ac:picMkLst>
        </pc:picChg>
        <pc:cxnChg chg="mod topLvl">
          <ac:chgData name="Sara Weis" userId="6a51f4e6-0e93-4a18-834c-a49e1ed77407" providerId="ADAL" clId="{6959E033-7E6A-4EA0-AB19-75F676599088}" dt="2025-01-02T17:00:26.168" v="180" actId="164"/>
          <ac:cxnSpMkLst>
            <pc:docMk/>
            <pc:sldMk cId="1407140874" sldId="309"/>
            <ac:cxnSpMk id="61" creationId="{60770B83-1127-4F2D-B417-7730032C6158}"/>
          </ac:cxnSpMkLst>
        </pc:cxnChg>
        <pc:cxnChg chg="mod topLvl">
          <ac:chgData name="Sara Weis" userId="6a51f4e6-0e93-4a18-834c-a49e1ed77407" providerId="ADAL" clId="{6959E033-7E6A-4EA0-AB19-75F676599088}" dt="2025-01-02T17:00:26.168" v="180" actId="164"/>
          <ac:cxnSpMkLst>
            <pc:docMk/>
            <pc:sldMk cId="1407140874" sldId="309"/>
            <ac:cxnSpMk id="65" creationId="{36869760-8BC8-400F-9233-EDB338402EF1}"/>
          </ac:cxnSpMkLst>
        </pc:cxnChg>
        <pc:cxnChg chg="mod topLvl">
          <ac:chgData name="Sara Weis" userId="6a51f4e6-0e93-4a18-834c-a49e1ed77407" providerId="ADAL" clId="{6959E033-7E6A-4EA0-AB19-75F676599088}" dt="2025-01-02T17:00:26.168" v="180" actId="164"/>
          <ac:cxnSpMkLst>
            <pc:docMk/>
            <pc:sldMk cId="1407140874" sldId="309"/>
            <ac:cxnSpMk id="68" creationId="{8162CB15-C774-43CB-8E29-6C531374815F}"/>
          </ac:cxnSpMkLst>
        </pc:cxnChg>
      </pc:sldChg>
      <pc:sldChg chg="addSp delSp modSp">
        <pc:chgData name="Sara Weis" userId="6a51f4e6-0e93-4a18-834c-a49e1ed77407" providerId="ADAL" clId="{6959E033-7E6A-4EA0-AB19-75F676599088}" dt="2025-01-02T17:16:52.628" v="391" actId="1076"/>
        <pc:sldMkLst>
          <pc:docMk/>
          <pc:sldMk cId="2712744224" sldId="311"/>
        </pc:sldMkLst>
        <pc:spChg chg="add mod">
          <ac:chgData name="Sara Weis" userId="6a51f4e6-0e93-4a18-834c-a49e1ed77407" providerId="ADAL" clId="{6959E033-7E6A-4EA0-AB19-75F676599088}" dt="2025-01-02T17:16:49.358" v="390" actId="403"/>
          <ac:spMkLst>
            <pc:docMk/>
            <pc:sldMk cId="2712744224" sldId="311"/>
            <ac:spMk id="2" creationId="{8FEA17E4-D707-40D4-B8A6-05A0F86B4ED8}"/>
          </ac:spMkLst>
        </pc:spChg>
        <pc:spChg chg="del">
          <ac:chgData name="Sara Weis" userId="6a51f4e6-0e93-4a18-834c-a49e1ed77407" providerId="ADAL" clId="{6959E033-7E6A-4EA0-AB19-75F676599088}" dt="2025-01-02T17:04:36.070" v="335" actId="478"/>
          <ac:spMkLst>
            <pc:docMk/>
            <pc:sldMk cId="2712744224" sldId="311"/>
            <ac:spMk id="4" creationId="{EFF1A090-F7E6-4492-A0E2-DB77C11864EC}"/>
          </ac:spMkLst>
        </pc:spChg>
        <pc:spChg chg="del">
          <ac:chgData name="Sara Weis" userId="6a51f4e6-0e93-4a18-834c-a49e1ed77407" providerId="ADAL" clId="{6959E033-7E6A-4EA0-AB19-75F676599088}" dt="2025-01-02T17:04:05.317" v="293" actId="478"/>
          <ac:spMkLst>
            <pc:docMk/>
            <pc:sldMk cId="2712744224" sldId="311"/>
            <ac:spMk id="8" creationId="{176DA74B-212B-4CD8-AD83-20D4227BE0BE}"/>
          </ac:spMkLst>
        </pc:spChg>
        <pc:spChg chg="add del mod">
          <ac:chgData name="Sara Weis" userId="6a51f4e6-0e93-4a18-834c-a49e1ed77407" providerId="ADAL" clId="{6959E033-7E6A-4EA0-AB19-75F676599088}" dt="2025-01-02T17:04:53.166" v="342" actId="478"/>
          <ac:spMkLst>
            <pc:docMk/>
            <pc:sldMk cId="2712744224" sldId="311"/>
            <ac:spMk id="31" creationId="{C56981B2-F415-4A9E-A873-F7DE5E9788A4}"/>
          </ac:spMkLst>
        </pc:spChg>
        <pc:grpChg chg="del">
          <ac:chgData name="Sara Weis" userId="6a51f4e6-0e93-4a18-834c-a49e1ed77407" providerId="ADAL" clId="{6959E033-7E6A-4EA0-AB19-75F676599088}" dt="2025-01-02T17:04:05.317" v="293" actId="478"/>
          <ac:grpSpMkLst>
            <pc:docMk/>
            <pc:sldMk cId="2712744224" sldId="311"/>
            <ac:grpSpMk id="17" creationId="{3AD46ADA-27C5-4509-BC5D-8E2838B8B03B}"/>
          </ac:grpSpMkLst>
        </pc:grpChg>
        <pc:grpChg chg="del">
          <ac:chgData name="Sara Weis" userId="6a51f4e6-0e93-4a18-834c-a49e1ed77407" providerId="ADAL" clId="{6959E033-7E6A-4EA0-AB19-75F676599088}" dt="2025-01-02T17:04:05.317" v="293" actId="478"/>
          <ac:grpSpMkLst>
            <pc:docMk/>
            <pc:sldMk cId="2712744224" sldId="311"/>
            <ac:grpSpMk id="32" creationId="{AEFCE027-3D20-461D-B064-12E9E1F01B51}"/>
          </ac:grpSpMkLst>
        </pc:grpChg>
        <pc:graphicFrameChg chg="del">
          <ac:chgData name="Sara Weis" userId="6a51f4e6-0e93-4a18-834c-a49e1ed77407" providerId="ADAL" clId="{6959E033-7E6A-4EA0-AB19-75F676599088}" dt="2025-01-02T17:04:05.317" v="293" actId="478"/>
          <ac:graphicFrameMkLst>
            <pc:docMk/>
            <pc:sldMk cId="2712744224" sldId="311"/>
            <ac:graphicFrameMk id="66" creationId="{111A6526-7355-44C6-8032-64EE94B50FD5}"/>
          </ac:graphicFrameMkLst>
        </pc:graphicFrameChg>
        <pc:picChg chg="mod">
          <ac:chgData name="Sara Weis" userId="6a51f4e6-0e93-4a18-834c-a49e1ed77407" providerId="ADAL" clId="{6959E033-7E6A-4EA0-AB19-75F676599088}" dt="2025-01-02T17:16:52.628" v="391" actId="1076"/>
          <ac:picMkLst>
            <pc:docMk/>
            <pc:sldMk cId="2712744224" sldId="311"/>
            <ac:picMk id="7" creationId="{1351158B-83E9-448C-978B-1EA485DEA316}"/>
          </ac:picMkLst>
        </pc:picChg>
        <pc:cxnChg chg="del">
          <ac:chgData name="Sara Weis" userId="6a51f4e6-0e93-4a18-834c-a49e1ed77407" providerId="ADAL" clId="{6959E033-7E6A-4EA0-AB19-75F676599088}" dt="2025-01-02T17:04:05.317" v="293" actId="478"/>
          <ac:cxnSpMkLst>
            <pc:docMk/>
            <pc:sldMk cId="2712744224" sldId="311"/>
            <ac:cxnSpMk id="67" creationId="{900452E5-2F38-400C-871D-592F39BB8149}"/>
          </ac:cxnSpMkLst>
        </pc:cxnChg>
      </pc:sldChg>
      <pc:sldChg chg="addSp delSp modSp add">
        <pc:chgData name="Sara Weis" userId="6a51f4e6-0e93-4a18-834c-a49e1ed77407" providerId="ADAL" clId="{6959E033-7E6A-4EA0-AB19-75F676599088}" dt="2025-01-02T17:17:59.407" v="418" actId="20577"/>
        <pc:sldMkLst>
          <pc:docMk/>
          <pc:sldMk cId="2356307124" sldId="312"/>
        </pc:sldMkLst>
        <pc:spChg chg="add mod">
          <ac:chgData name="Sara Weis" userId="6a51f4e6-0e93-4a18-834c-a49e1ed77407" providerId="ADAL" clId="{6959E033-7E6A-4EA0-AB19-75F676599088}" dt="2025-01-02T17:17:59.407" v="418" actId="20577"/>
          <ac:spMkLst>
            <pc:docMk/>
            <pc:sldMk cId="2356307124" sldId="312"/>
            <ac:spMk id="2" creationId="{4D9D5902-05D5-4827-AE64-44E64AA62EA2}"/>
          </ac:spMkLst>
        </pc:spChg>
        <pc:spChg chg="del">
          <ac:chgData name="Sara Weis" userId="6a51f4e6-0e93-4a18-834c-a49e1ed77407" providerId="ADAL" clId="{6959E033-7E6A-4EA0-AB19-75F676599088}" dt="2025-01-02T17:02:44.579" v="235" actId="478"/>
          <ac:spMkLst>
            <pc:docMk/>
            <pc:sldMk cId="2356307124" sldId="312"/>
            <ac:spMk id="4" creationId="{EFF1A090-F7E6-4492-A0E2-DB77C11864EC}"/>
          </ac:spMkLst>
        </pc:spChg>
        <pc:spChg chg="del">
          <ac:chgData name="Sara Weis" userId="6a51f4e6-0e93-4a18-834c-a49e1ed77407" providerId="ADAL" clId="{6959E033-7E6A-4EA0-AB19-75F676599088}" dt="2025-01-02T17:02:49.963" v="238" actId="478"/>
          <ac:spMkLst>
            <pc:docMk/>
            <pc:sldMk cId="2356307124" sldId="312"/>
            <ac:spMk id="8" creationId="{176DA74B-212B-4CD8-AD83-20D4227BE0BE}"/>
          </ac:spMkLst>
        </pc:spChg>
        <pc:spChg chg="del mod">
          <ac:chgData name="Sara Weis" userId="6a51f4e6-0e93-4a18-834c-a49e1ed77407" providerId="ADAL" clId="{6959E033-7E6A-4EA0-AB19-75F676599088}" dt="2025-01-02T17:04:58.125" v="343" actId="478"/>
          <ac:spMkLst>
            <pc:docMk/>
            <pc:sldMk cId="2356307124" sldId="312"/>
            <ac:spMk id="31" creationId="{C56981B2-F415-4A9E-A873-F7DE5E9788A4}"/>
          </ac:spMkLst>
        </pc:spChg>
        <pc:spChg chg="mod">
          <ac:chgData name="Sara Weis" userId="6a51f4e6-0e93-4a18-834c-a49e1ed77407" providerId="ADAL" clId="{6959E033-7E6A-4EA0-AB19-75F676599088}" dt="2025-01-02T17:17:16.576" v="404" actId="404"/>
          <ac:spMkLst>
            <pc:docMk/>
            <pc:sldMk cId="2356307124" sldId="312"/>
            <ac:spMk id="34" creationId="{7245DFBF-E367-42CE-9BC0-1CC284935543}"/>
          </ac:spMkLst>
        </pc:spChg>
        <pc:spChg chg="mod">
          <ac:chgData name="Sara Weis" userId="6a51f4e6-0e93-4a18-834c-a49e1ed77407" providerId="ADAL" clId="{6959E033-7E6A-4EA0-AB19-75F676599088}" dt="2025-01-02T17:17:20.827" v="405" actId="1076"/>
          <ac:spMkLst>
            <pc:docMk/>
            <pc:sldMk cId="2356307124" sldId="312"/>
            <ac:spMk id="35" creationId="{FF84D828-1683-4212-9A04-530622F68783}"/>
          </ac:spMkLst>
        </pc:spChg>
        <pc:spChg chg="mod">
          <ac:chgData name="Sara Weis" userId="6a51f4e6-0e93-4a18-834c-a49e1ed77407" providerId="ADAL" clId="{6959E033-7E6A-4EA0-AB19-75F676599088}" dt="2025-01-02T17:17:24.806" v="407" actId="14100"/>
          <ac:spMkLst>
            <pc:docMk/>
            <pc:sldMk cId="2356307124" sldId="312"/>
            <ac:spMk id="36" creationId="{1FC9477D-6E24-442C-9FA5-58E70ABD35D1}"/>
          </ac:spMkLst>
        </pc:spChg>
        <pc:spChg chg="mod">
          <ac:chgData name="Sara Weis" userId="6a51f4e6-0e93-4a18-834c-a49e1ed77407" providerId="ADAL" clId="{6959E033-7E6A-4EA0-AB19-75F676599088}" dt="2025-01-02T17:17:27.382" v="408" actId="1076"/>
          <ac:spMkLst>
            <pc:docMk/>
            <pc:sldMk cId="2356307124" sldId="312"/>
            <ac:spMk id="37" creationId="{77012511-9E81-45CF-B84C-A520A6C63417}"/>
          </ac:spMkLst>
        </pc:spChg>
        <pc:spChg chg="mod">
          <ac:chgData name="Sara Weis" userId="6a51f4e6-0e93-4a18-834c-a49e1ed77407" providerId="ADAL" clId="{6959E033-7E6A-4EA0-AB19-75F676599088}" dt="2025-01-02T17:17:16.576" v="404" actId="404"/>
          <ac:spMkLst>
            <pc:docMk/>
            <pc:sldMk cId="2356307124" sldId="312"/>
            <ac:spMk id="38" creationId="{3DB68739-9E51-4261-B67F-EEB63C4BA948}"/>
          </ac:spMkLst>
        </pc:spChg>
        <pc:spChg chg="mod">
          <ac:chgData name="Sara Weis" userId="6a51f4e6-0e93-4a18-834c-a49e1ed77407" providerId="ADAL" clId="{6959E033-7E6A-4EA0-AB19-75F676599088}" dt="2025-01-02T17:17:16.576" v="404" actId="404"/>
          <ac:spMkLst>
            <pc:docMk/>
            <pc:sldMk cId="2356307124" sldId="312"/>
            <ac:spMk id="39" creationId="{B5400EC5-E183-4B29-A883-E4711603516E}"/>
          </ac:spMkLst>
        </pc:spChg>
        <pc:grpChg chg="add del mod">
          <ac:chgData name="Sara Weis" userId="6a51f4e6-0e93-4a18-834c-a49e1ed77407" providerId="ADAL" clId="{6959E033-7E6A-4EA0-AB19-75F676599088}" dt="2025-01-02T17:17:10.519" v="396" actId="165"/>
          <ac:grpSpMkLst>
            <pc:docMk/>
            <pc:sldMk cId="2356307124" sldId="312"/>
            <ac:grpSpMk id="5" creationId="{F0736E05-44C9-4E0F-B450-06399BD2E38F}"/>
          </ac:grpSpMkLst>
        </pc:grpChg>
        <pc:grpChg chg="mod topLvl">
          <ac:chgData name="Sara Weis" userId="6a51f4e6-0e93-4a18-834c-a49e1ed77407" providerId="ADAL" clId="{6959E033-7E6A-4EA0-AB19-75F676599088}" dt="2025-01-02T17:17:52.766" v="415" actId="1076"/>
          <ac:grpSpMkLst>
            <pc:docMk/>
            <pc:sldMk cId="2356307124" sldId="312"/>
            <ac:grpSpMk id="17" creationId="{3AD46ADA-27C5-4509-BC5D-8E2838B8B03B}"/>
          </ac:grpSpMkLst>
        </pc:grpChg>
        <pc:grpChg chg="mod topLvl">
          <ac:chgData name="Sara Weis" userId="6a51f4e6-0e93-4a18-834c-a49e1ed77407" providerId="ADAL" clId="{6959E033-7E6A-4EA0-AB19-75F676599088}" dt="2025-01-02T17:17:52.766" v="415" actId="1076"/>
          <ac:grpSpMkLst>
            <pc:docMk/>
            <pc:sldMk cId="2356307124" sldId="312"/>
            <ac:grpSpMk id="32" creationId="{AEFCE027-3D20-461D-B064-12E9E1F01B51}"/>
          </ac:grpSpMkLst>
        </pc:grpChg>
        <pc:grpChg chg="mod">
          <ac:chgData name="Sara Weis" userId="6a51f4e6-0e93-4a18-834c-a49e1ed77407" providerId="ADAL" clId="{6959E033-7E6A-4EA0-AB19-75F676599088}" dt="2025-01-02T17:17:52.766" v="415" actId="1076"/>
          <ac:grpSpMkLst>
            <pc:docMk/>
            <pc:sldMk cId="2356307124" sldId="312"/>
            <ac:grpSpMk id="33" creationId="{2ED8BAA9-40D7-40CC-906F-F42E40F72D84}"/>
          </ac:grpSpMkLst>
        </pc:grpChg>
        <pc:graphicFrameChg chg="mod topLvl">
          <ac:chgData name="Sara Weis" userId="6a51f4e6-0e93-4a18-834c-a49e1ed77407" providerId="ADAL" clId="{6959E033-7E6A-4EA0-AB19-75F676599088}" dt="2025-01-02T17:17:52.766" v="415" actId="1076"/>
          <ac:graphicFrameMkLst>
            <pc:docMk/>
            <pc:sldMk cId="2356307124" sldId="312"/>
            <ac:graphicFrameMk id="66" creationId="{111A6526-7355-44C6-8032-64EE94B50FD5}"/>
          </ac:graphicFrameMkLst>
        </pc:graphicFrameChg>
        <pc:picChg chg="mod">
          <ac:chgData name="Sara Weis" userId="6a51f4e6-0e93-4a18-834c-a49e1ed77407" providerId="ADAL" clId="{6959E033-7E6A-4EA0-AB19-75F676599088}" dt="2025-01-02T17:05:17.936" v="349" actId="1076"/>
          <ac:picMkLst>
            <pc:docMk/>
            <pc:sldMk cId="2356307124" sldId="312"/>
            <ac:picMk id="3" creationId="{A6327666-5840-B3BB-17A2-7B4D54247304}"/>
          </ac:picMkLst>
        </pc:picChg>
        <pc:picChg chg="del">
          <ac:chgData name="Sara Weis" userId="6a51f4e6-0e93-4a18-834c-a49e1ed77407" providerId="ADAL" clId="{6959E033-7E6A-4EA0-AB19-75F676599088}" dt="2025-01-02T17:02:44.579" v="235" actId="478"/>
          <ac:picMkLst>
            <pc:docMk/>
            <pc:sldMk cId="2356307124" sldId="312"/>
            <ac:picMk id="7" creationId="{1351158B-83E9-448C-978B-1EA485DEA316}"/>
          </ac:picMkLst>
        </pc:picChg>
        <pc:cxnChg chg="mod topLvl">
          <ac:chgData name="Sara Weis" userId="6a51f4e6-0e93-4a18-834c-a49e1ed77407" providerId="ADAL" clId="{6959E033-7E6A-4EA0-AB19-75F676599088}" dt="2025-01-02T17:17:52.766" v="415" actId="1076"/>
          <ac:cxnSpMkLst>
            <pc:docMk/>
            <pc:sldMk cId="2356307124" sldId="312"/>
            <ac:cxnSpMk id="67" creationId="{900452E5-2F38-400C-871D-592F39BB8149}"/>
          </ac:cxnSpMkLst>
        </pc:cxnChg>
      </pc:sldChg>
    </pc:docChg>
  </pc:docChgLst>
  <pc:docChgLst>
    <pc:chgData name="Sara Weis" userId="6a51f4e6-0e93-4a18-834c-a49e1ed77407" providerId="ADAL" clId="{5B9D748F-4140-4F29-A6FB-884F3F5921E6}"/>
    <pc:docChg chg="delSld modSld">
      <pc:chgData name="Sara Weis" userId="6a51f4e6-0e93-4a18-834c-a49e1ed77407" providerId="ADAL" clId="{5B9D748F-4140-4F29-A6FB-884F3F5921E6}" dt="2025-01-02T16:47:04.763" v="12" actId="20577"/>
      <pc:docMkLst>
        <pc:docMk/>
      </pc:docMkLst>
      <pc:sldChg chg="modSp">
        <pc:chgData name="Sara Weis" userId="6a51f4e6-0e93-4a18-834c-a49e1ed77407" providerId="ADAL" clId="{5B9D748F-4140-4F29-A6FB-884F3F5921E6}" dt="2025-01-02T16:46:55.225" v="6" actId="20577"/>
        <pc:sldMkLst>
          <pc:docMk/>
          <pc:sldMk cId="2106248321" sldId="298"/>
        </pc:sldMkLst>
        <pc:spChg chg="mod">
          <ac:chgData name="Sara Weis" userId="6a51f4e6-0e93-4a18-834c-a49e1ed77407" providerId="ADAL" clId="{5B9D748F-4140-4F29-A6FB-884F3F5921E6}" dt="2025-01-02T16:46:52.776" v="4" actId="20577"/>
          <ac:spMkLst>
            <pc:docMk/>
            <pc:sldMk cId="2106248321" sldId="298"/>
            <ac:spMk id="23" creationId="{9837469B-6902-495A-86E3-722D7C6A57DC}"/>
          </ac:spMkLst>
        </pc:spChg>
        <pc:spChg chg="mod">
          <ac:chgData name="Sara Weis" userId="6a51f4e6-0e93-4a18-834c-a49e1ed77407" providerId="ADAL" clId="{5B9D748F-4140-4F29-A6FB-884F3F5921E6}" dt="2025-01-02T16:46:48.408" v="2" actId="20577"/>
          <ac:spMkLst>
            <pc:docMk/>
            <pc:sldMk cId="2106248321" sldId="298"/>
            <ac:spMk id="45" creationId="{F3A9156C-C54C-4614-ABB9-5AF095F0F775}"/>
          </ac:spMkLst>
        </pc:spChg>
        <pc:spChg chg="mod">
          <ac:chgData name="Sara Weis" userId="6a51f4e6-0e93-4a18-834c-a49e1ed77407" providerId="ADAL" clId="{5B9D748F-4140-4F29-A6FB-884F3F5921E6}" dt="2025-01-02T16:46:55.225" v="6" actId="20577"/>
          <ac:spMkLst>
            <pc:docMk/>
            <pc:sldMk cId="2106248321" sldId="298"/>
            <ac:spMk id="70" creationId="{7A30D47F-4FE9-4840-9977-6022DD4A371A}"/>
          </ac:spMkLst>
        </pc:spChg>
      </pc:sldChg>
      <pc:sldChg chg="del">
        <pc:chgData name="Sara Weis" userId="6a51f4e6-0e93-4a18-834c-a49e1ed77407" providerId="ADAL" clId="{5B9D748F-4140-4F29-A6FB-884F3F5921E6}" dt="2025-01-02T16:46:43.245" v="0" actId="2696"/>
        <pc:sldMkLst>
          <pc:docMk/>
          <pc:sldMk cId="3697787146" sldId="301"/>
        </pc:sldMkLst>
      </pc:sldChg>
      <pc:sldChg chg="modSp">
        <pc:chgData name="Sara Weis" userId="6a51f4e6-0e93-4a18-834c-a49e1ed77407" providerId="ADAL" clId="{5B9D748F-4140-4F29-A6FB-884F3F5921E6}" dt="2025-01-02T16:46:58.680" v="8" actId="20577"/>
        <pc:sldMkLst>
          <pc:docMk/>
          <pc:sldMk cId="1407140874" sldId="309"/>
        </pc:sldMkLst>
        <pc:spChg chg="mod">
          <ac:chgData name="Sara Weis" userId="6a51f4e6-0e93-4a18-834c-a49e1ed77407" providerId="ADAL" clId="{5B9D748F-4140-4F29-A6FB-884F3F5921E6}" dt="2025-01-02T16:46:58.680" v="8" actId="20577"/>
          <ac:spMkLst>
            <pc:docMk/>
            <pc:sldMk cId="1407140874" sldId="309"/>
            <ac:spMk id="5" creationId="{B847A6B5-FE3F-456F-A592-96E2D8DDCCD8}"/>
          </ac:spMkLst>
        </pc:spChg>
      </pc:sldChg>
      <pc:sldChg chg="modSp">
        <pc:chgData name="Sara Weis" userId="6a51f4e6-0e93-4a18-834c-a49e1ed77407" providerId="ADAL" clId="{5B9D748F-4140-4F29-A6FB-884F3F5921E6}" dt="2025-01-02T16:47:04.763" v="12" actId="20577"/>
        <pc:sldMkLst>
          <pc:docMk/>
          <pc:sldMk cId="2712744224" sldId="311"/>
        </pc:sldMkLst>
        <pc:spChg chg="mod">
          <ac:chgData name="Sara Weis" userId="6a51f4e6-0e93-4a18-834c-a49e1ed77407" providerId="ADAL" clId="{5B9D748F-4140-4F29-A6FB-884F3F5921E6}" dt="2025-01-02T16:47:02.568" v="10" actId="20577"/>
          <ac:spMkLst>
            <pc:docMk/>
            <pc:sldMk cId="2712744224" sldId="311"/>
            <ac:spMk id="4" creationId="{EFF1A090-F7E6-4492-A0E2-DB77C11864EC}"/>
          </ac:spMkLst>
        </pc:spChg>
        <pc:spChg chg="mod">
          <ac:chgData name="Sara Weis" userId="6a51f4e6-0e93-4a18-834c-a49e1ed77407" providerId="ADAL" clId="{5B9D748F-4140-4F29-A6FB-884F3F5921E6}" dt="2025-01-02T16:47:04.763" v="12" actId="20577"/>
          <ac:spMkLst>
            <pc:docMk/>
            <pc:sldMk cId="2712744224" sldId="311"/>
            <ac:spMk id="8" creationId="{176DA74B-212B-4CD8-AD83-20D4227BE0BE}"/>
          </ac:spMkLst>
        </pc:spChg>
      </pc:sldChg>
    </pc:docChg>
  </pc:docChgLst>
  <pc:docChgLst>
    <pc:chgData name="Sara Weis" userId="6a51f4e6-0e93-4a18-834c-a49e1ed77407" providerId="ADAL" clId="{94C59196-373D-4882-A6D6-736C9CF8C9BB}"/>
    <pc:docChg chg="delSld">
      <pc:chgData name="Sara Weis" userId="6a51f4e6-0e93-4a18-834c-a49e1ed77407" providerId="ADAL" clId="{94C59196-373D-4882-A6D6-736C9CF8C9BB}" dt="2025-01-02T17:22:46.374" v="2" actId="2696"/>
      <pc:docMkLst>
        <pc:docMk/>
      </pc:docMkLst>
      <pc:sldChg chg="del">
        <pc:chgData name="Sara Weis" userId="6a51f4e6-0e93-4a18-834c-a49e1ed77407" providerId="ADAL" clId="{94C59196-373D-4882-A6D6-736C9CF8C9BB}" dt="2025-01-02T17:22:46.359" v="0" actId="2696"/>
        <pc:sldMkLst>
          <pc:docMk/>
          <pc:sldMk cId="1407140874" sldId="309"/>
        </pc:sldMkLst>
      </pc:sldChg>
      <pc:sldChg chg="del">
        <pc:chgData name="Sara Weis" userId="6a51f4e6-0e93-4a18-834c-a49e1ed77407" providerId="ADAL" clId="{94C59196-373D-4882-A6D6-736C9CF8C9BB}" dt="2025-01-02T17:22:46.366" v="1" actId="2696"/>
        <pc:sldMkLst>
          <pc:docMk/>
          <pc:sldMk cId="2712744224" sldId="311"/>
        </pc:sldMkLst>
      </pc:sldChg>
      <pc:sldChg chg="del">
        <pc:chgData name="Sara Weis" userId="6a51f4e6-0e93-4a18-834c-a49e1ed77407" providerId="ADAL" clId="{94C59196-373D-4882-A6D6-736C9CF8C9BB}" dt="2025-01-02T17:22:46.374" v="2" actId="2696"/>
        <pc:sldMkLst>
          <pc:docMk/>
          <pc:sldMk cId="2356307124" sldId="312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8556F641-4CF0-450A-AF50-26BA00F47CDE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06F44C2-743C-4165-B45D-193A312A7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7285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6F44C2-743C-4165-B45D-193A312A7D2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0062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250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769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329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291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570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90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7310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15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96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0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21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204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60064E3-9BEA-4925-8610-BCA826CE0C41}"/>
              </a:ext>
            </a:extLst>
          </p:cNvPr>
          <p:cNvGrpSpPr/>
          <p:nvPr/>
        </p:nvGrpSpPr>
        <p:grpSpPr>
          <a:xfrm>
            <a:off x="219015" y="1718092"/>
            <a:ext cx="6271937" cy="8132023"/>
            <a:chOff x="-150572" y="332382"/>
            <a:chExt cx="6807540" cy="8826472"/>
          </a:xfrm>
        </p:grpSpPr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6C3C0227-C401-42B7-83D7-5BCA28C7679E}"/>
                </a:ext>
              </a:extLst>
            </p:cNvPr>
            <p:cNvGrpSpPr/>
            <p:nvPr/>
          </p:nvGrpSpPr>
          <p:grpSpPr>
            <a:xfrm>
              <a:off x="282293" y="332382"/>
              <a:ext cx="6374675" cy="3409481"/>
              <a:chOff x="106807" y="3009298"/>
              <a:chExt cx="6663323" cy="3563864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FE4CC9D9-8DD3-4459-88D3-B8F79424DA6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433166" y="3271540"/>
                <a:ext cx="1673970" cy="1624575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8A932304-E384-48B7-BE82-703EBBDE4DF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107136" y="3271540"/>
                <a:ext cx="1662994" cy="1657505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B958FC3F-47F1-4CB1-BC90-FABE7D21EA5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779091" y="3271540"/>
                <a:ext cx="1657505" cy="1646528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C1471C23-98E7-4A57-9306-435F6C7EB7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11981" y="3255075"/>
                <a:ext cx="1662994" cy="1657505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5936999-04B7-4CA0-96C9-CD97C06BD1F1}"/>
                  </a:ext>
                </a:extLst>
              </p:cNvPr>
              <p:cNvSpPr txBox="1"/>
              <p:nvPr/>
            </p:nvSpPr>
            <p:spPr>
              <a:xfrm>
                <a:off x="2150468" y="3009298"/>
                <a:ext cx="878539" cy="2934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Anti-</a:t>
                </a:r>
                <a:r>
                  <a:rPr lang="el-GR" sz="105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v</a:t>
                </a:r>
                <a:r>
                  <a:rPr lang="el-GR" sz="105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98561D18-56B5-4A22-B657-19C0C43B029A}"/>
                  </a:ext>
                </a:extLst>
              </p:cNvPr>
              <p:cNvSpPr txBox="1"/>
              <p:nvPr/>
            </p:nvSpPr>
            <p:spPr>
              <a:xfrm>
                <a:off x="3821054" y="3024843"/>
                <a:ext cx="887803" cy="2934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Anti-</a:t>
                </a:r>
                <a:r>
                  <a:rPr lang="el-GR" sz="105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r>
                  <a:rPr lang="el-GR" sz="105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06F6387F-5DC2-44EE-B710-A3F4811AD05E}"/>
                  </a:ext>
                </a:extLst>
              </p:cNvPr>
              <p:cNvSpPr txBox="1"/>
              <p:nvPr/>
            </p:nvSpPr>
            <p:spPr>
              <a:xfrm>
                <a:off x="5385424" y="3024843"/>
                <a:ext cx="1106418" cy="2934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Bispecific Ab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B599E299-20AD-4B90-863E-C9F21A3FC407}"/>
                  </a:ext>
                </a:extLst>
              </p:cNvPr>
              <p:cNvSpPr txBox="1"/>
              <p:nvPr/>
            </p:nvSpPr>
            <p:spPr>
              <a:xfrm>
                <a:off x="175826" y="3024843"/>
                <a:ext cx="1599232" cy="2934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IgG4 isotype control</a:t>
                </a:r>
              </a:p>
            </p:txBody>
          </p:sp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EA8E618D-3038-477C-9651-A6D52EFF40A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06807" y="4926393"/>
                <a:ext cx="1646768" cy="1640601"/>
              </a:xfrm>
              <a:prstGeom prst="rect">
                <a:avLst/>
              </a:prstGeom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29E31D09-E169-48AD-AEA7-D8F651A941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774974" y="4926394"/>
                <a:ext cx="1652936" cy="1628266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B47B66EF-77FE-4B53-8860-B9ECD3FEAD4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433166" y="4926394"/>
                <a:ext cx="1665271" cy="1646768"/>
              </a:xfrm>
              <a:prstGeom prst="rect">
                <a:avLst/>
              </a:prstGeom>
            </p:spPr>
          </p:pic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E8AE1180-C773-4685-BC18-12DEB9BC07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5101962" y="4926394"/>
                <a:ext cx="1646768" cy="1646768"/>
              </a:xfrm>
              <a:prstGeom prst="rect">
                <a:avLst/>
              </a:prstGeom>
            </p:spPr>
          </p:pic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36DD729-0233-4845-B1E1-FF2549A9C872}"/>
                </a:ext>
              </a:extLst>
            </p:cNvPr>
            <p:cNvSpPr txBox="1"/>
            <p:nvPr/>
          </p:nvSpPr>
          <p:spPr>
            <a:xfrm rot="16200000">
              <a:off x="1203" y="1219990"/>
              <a:ext cx="402694" cy="2807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N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7F2151C-91AE-444F-BA0A-F5DE6A8495AA}"/>
                </a:ext>
              </a:extLst>
            </p:cNvPr>
            <p:cNvSpPr txBox="1"/>
            <p:nvPr/>
          </p:nvSpPr>
          <p:spPr>
            <a:xfrm rot="16200000">
              <a:off x="-512530" y="2813772"/>
              <a:ext cx="1418291" cy="2807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r>
                <a:rPr lang="en-US" sz="1050">
                  <a:latin typeface="Arial" panose="020B0604020202020204" pitchFamily="34" charset="0"/>
                  <a:cs typeface="Arial" panose="020B0604020202020204" pitchFamily="34" charset="0"/>
                </a:rPr>
                <a:t> + </a:t>
              </a:r>
              <a:r>
                <a:rPr lang="en-US" sz="105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N </a:t>
              </a:r>
              <a:r>
                <a:rPr lang="en-US" sz="105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sz="105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837469B-6902-495A-86E3-722D7C6A57DC}"/>
                </a:ext>
              </a:extLst>
            </p:cNvPr>
            <p:cNvSpPr txBox="1"/>
            <p:nvPr/>
          </p:nvSpPr>
          <p:spPr>
            <a:xfrm>
              <a:off x="-150572" y="477129"/>
              <a:ext cx="347750" cy="3403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7A30D47F-4FE9-4840-9977-6022DD4A371A}"/>
                </a:ext>
              </a:extLst>
            </p:cNvPr>
            <p:cNvSpPr txBox="1"/>
            <p:nvPr/>
          </p:nvSpPr>
          <p:spPr>
            <a:xfrm>
              <a:off x="-150572" y="4096248"/>
              <a:ext cx="347750" cy="3403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444086A9-B7E4-41B3-B776-3280FA8A5349}"/>
                </a:ext>
              </a:extLst>
            </p:cNvPr>
            <p:cNvCxnSpPr>
              <a:cxnSpLocks/>
            </p:cNvCxnSpPr>
            <p:nvPr/>
          </p:nvCxnSpPr>
          <p:spPr>
            <a:xfrm>
              <a:off x="6367877" y="3855072"/>
              <a:ext cx="24195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1CE285CC-DC0D-4825-9EDF-E3D5D8427719}"/>
                </a:ext>
              </a:extLst>
            </p:cNvPr>
            <p:cNvSpPr txBox="1"/>
            <p:nvPr/>
          </p:nvSpPr>
          <p:spPr>
            <a:xfrm>
              <a:off x="5706019" y="3723585"/>
              <a:ext cx="796665" cy="2552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50 µm</a:t>
              </a:r>
            </a:p>
          </p:txBody>
        </p: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D5F64F85-735E-4924-B238-3BB390ADA6D2}"/>
                </a:ext>
              </a:extLst>
            </p:cNvPr>
            <p:cNvGrpSpPr/>
            <p:nvPr/>
          </p:nvGrpSpPr>
          <p:grpSpPr>
            <a:xfrm>
              <a:off x="100926" y="3992643"/>
              <a:ext cx="6556041" cy="5166211"/>
              <a:chOff x="1292478" y="4954124"/>
              <a:chExt cx="5247896" cy="4135380"/>
            </a:xfrm>
          </p:grpSpPr>
          <p:grpSp>
            <p:nvGrpSpPr>
              <p:cNvPr id="87" name="Group 86">
                <a:extLst>
                  <a:ext uri="{FF2B5EF4-FFF2-40B4-BE49-F238E27FC236}">
                    <a16:creationId xmlns:a16="http://schemas.microsoft.com/office/drawing/2014/main" id="{22DB2EEB-BFED-445A-9F04-0C67BB4A0C2C}"/>
                  </a:ext>
                </a:extLst>
              </p:cNvPr>
              <p:cNvGrpSpPr/>
              <p:nvPr/>
            </p:nvGrpSpPr>
            <p:grpSpPr>
              <a:xfrm rot="5400000" flipV="1">
                <a:off x="2765680" y="3877471"/>
                <a:ext cx="2509095" cy="5016920"/>
                <a:chOff x="5672115" y="19784"/>
                <a:chExt cx="2367714" cy="6164550"/>
              </a:xfrm>
            </p:grpSpPr>
            <p:pic>
              <p:nvPicPr>
                <p:cNvPr id="89" name="Picture 88">
                  <a:extLst>
                    <a:ext uri="{FF2B5EF4-FFF2-40B4-BE49-F238E27FC236}">
                      <a16:creationId xmlns:a16="http://schemas.microsoft.com/office/drawing/2014/main" id="{13EB1F50-878F-4B49-91BB-F3F97D29C41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/>
                <a:srcRect l="49915"/>
                <a:stretch/>
              </p:blipFill>
              <p:spPr>
                <a:xfrm>
                  <a:off x="5685355" y="19784"/>
                  <a:ext cx="2354474" cy="1495622"/>
                </a:xfrm>
                <a:prstGeom prst="rect">
                  <a:avLst/>
                </a:prstGeom>
              </p:spPr>
            </p:pic>
            <p:pic>
              <p:nvPicPr>
                <p:cNvPr id="90" name="Picture 89">
                  <a:extLst>
                    <a:ext uri="{FF2B5EF4-FFF2-40B4-BE49-F238E27FC236}">
                      <a16:creationId xmlns:a16="http://schemas.microsoft.com/office/drawing/2014/main" id="{8DA9A399-904B-4B47-BBD9-3AB4D876794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/>
                <a:srcRect l="49915"/>
                <a:stretch/>
              </p:blipFill>
              <p:spPr>
                <a:xfrm>
                  <a:off x="5683794" y="1556160"/>
                  <a:ext cx="2350783" cy="1495622"/>
                </a:xfrm>
                <a:prstGeom prst="rect">
                  <a:avLst/>
                </a:prstGeom>
              </p:spPr>
            </p:pic>
            <p:pic>
              <p:nvPicPr>
                <p:cNvPr id="91" name="Picture 90">
                  <a:extLst>
                    <a:ext uri="{FF2B5EF4-FFF2-40B4-BE49-F238E27FC236}">
                      <a16:creationId xmlns:a16="http://schemas.microsoft.com/office/drawing/2014/main" id="{E385389A-CD1E-46F4-8718-7CEA7B6966D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/>
                <a:srcRect l="50011"/>
                <a:stretch/>
              </p:blipFill>
              <p:spPr>
                <a:xfrm>
                  <a:off x="5672115" y="3128703"/>
                  <a:ext cx="2351193" cy="1495622"/>
                </a:xfrm>
                <a:prstGeom prst="rect">
                  <a:avLst/>
                </a:prstGeom>
              </p:spPr>
            </p:pic>
            <p:pic>
              <p:nvPicPr>
                <p:cNvPr id="92" name="Picture 91">
                  <a:extLst>
                    <a:ext uri="{FF2B5EF4-FFF2-40B4-BE49-F238E27FC236}">
                      <a16:creationId xmlns:a16="http://schemas.microsoft.com/office/drawing/2014/main" id="{D8249D59-BCC0-4BEB-BC55-BAB3D60D15F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/>
                <a:srcRect l="49915"/>
                <a:stretch/>
              </p:blipFill>
              <p:spPr>
                <a:xfrm>
                  <a:off x="5685448" y="4688712"/>
                  <a:ext cx="2349563" cy="1495622"/>
                </a:xfrm>
                <a:prstGeom prst="rect">
                  <a:avLst/>
                </a:prstGeom>
              </p:spPr>
            </p:pic>
          </p:grp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5C118BE6-EAB6-49A0-8589-3C1535D4CA55}"/>
                  </a:ext>
                </a:extLst>
              </p:cNvPr>
              <p:cNvSpPr txBox="1"/>
              <p:nvPr/>
            </p:nvSpPr>
            <p:spPr>
              <a:xfrm>
                <a:off x="1867751" y="4954136"/>
                <a:ext cx="549347" cy="2247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en-US" sz="105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329C40DA-0FB1-4ACB-86EA-3F951D6D6367}"/>
                  </a:ext>
                </a:extLst>
              </p:cNvPr>
              <p:cNvGrpSpPr/>
              <p:nvPr/>
            </p:nvGrpSpPr>
            <p:grpSpPr>
              <a:xfrm flipV="1">
                <a:off x="1511768" y="7655394"/>
                <a:ext cx="5028606" cy="1260209"/>
                <a:chOff x="2050950" y="8452221"/>
                <a:chExt cx="5028606" cy="1260209"/>
              </a:xfrm>
            </p:grpSpPr>
            <p:pic>
              <p:nvPicPr>
                <p:cNvPr id="80" name="Picture 79">
                  <a:extLst>
                    <a:ext uri="{FF2B5EF4-FFF2-40B4-BE49-F238E27FC236}">
                      <a16:creationId xmlns:a16="http://schemas.microsoft.com/office/drawing/2014/main" id="{889D425C-BA14-4679-A0EB-F78847A2486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/>
                <a:srcRect r="75105"/>
                <a:stretch/>
              </p:blipFill>
              <p:spPr>
                <a:xfrm rot="16200000">
                  <a:off x="2039445" y="8463726"/>
                  <a:ext cx="1240198" cy="1217188"/>
                </a:xfrm>
                <a:prstGeom prst="rect">
                  <a:avLst/>
                </a:prstGeom>
              </p:spPr>
            </p:pic>
            <p:pic>
              <p:nvPicPr>
                <p:cNvPr id="81" name="Picture 80">
                  <a:extLst>
                    <a:ext uri="{FF2B5EF4-FFF2-40B4-BE49-F238E27FC236}">
                      <a16:creationId xmlns:a16="http://schemas.microsoft.com/office/drawing/2014/main" id="{4E25BA96-62DD-4291-84B5-67AE5C647F5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/>
                <a:srcRect r="74928"/>
                <a:stretch/>
              </p:blipFill>
              <p:spPr>
                <a:xfrm rot="16200000">
                  <a:off x="3295734" y="8469050"/>
                  <a:ext cx="1247047" cy="1217188"/>
                </a:xfrm>
                <a:prstGeom prst="rect">
                  <a:avLst/>
                </a:prstGeom>
              </p:spPr>
            </p:pic>
            <p:pic>
              <p:nvPicPr>
                <p:cNvPr id="82" name="Picture 81">
                  <a:extLst>
                    <a:ext uri="{FF2B5EF4-FFF2-40B4-BE49-F238E27FC236}">
                      <a16:creationId xmlns:a16="http://schemas.microsoft.com/office/drawing/2014/main" id="{64A8399D-86E2-40CD-81A0-96E4EDECF1A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/>
                <a:srcRect r="75105"/>
                <a:stretch/>
              </p:blipFill>
              <p:spPr>
                <a:xfrm rot="16200000">
                  <a:off x="4575284" y="8478263"/>
                  <a:ext cx="1251147" cy="1217188"/>
                </a:xfrm>
                <a:prstGeom prst="rect">
                  <a:avLst/>
                </a:prstGeom>
              </p:spPr>
            </p:pic>
            <p:pic>
              <p:nvPicPr>
                <p:cNvPr id="83" name="Picture 82">
                  <a:extLst>
                    <a:ext uri="{FF2B5EF4-FFF2-40B4-BE49-F238E27FC236}">
                      <a16:creationId xmlns:a16="http://schemas.microsoft.com/office/drawing/2014/main" id="{5A325C7A-8A81-4C1E-84AD-8F9126DAB01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/>
                <a:srcRect r="75105"/>
                <a:stretch/>
              </p:blipFill>
              <p:spPr>
                <a:xfrm rot="16200000">
                  <a:off x="5852157" y="8467744"/>
                  <a:ext cx="1237609" cy="1217188"/>
                </a:xfrm>
                <a:prstGeom prst="rect">
                  <a:avLst/>
                </a:prstGeom>
              </p:spPr>
            </p:pic>
          </p:grp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B5744F81-4DF0-4530-87BD-B543F756DD8F}"/>
                  </a:ext>
                </a:extLst>
              </p:cNvPr>
              <p:cNvSpPr txBox="1"/>
              <p:nvPr/>
            </p:nvSpPr>
            <p:spPr>
              <a:xfrm>
                <a:off x="4295550" y="4954124"/>
                <a:ext cx="679873" cy="2247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462915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5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nti-</a:t>
                </a:r>
                <a:r>
                  <a:rPr kumimoji="0" lang="el-GR" sz="105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kumimoji="0" lang="en-US" sz="105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r>
                  <a:rPr kumimoji="0" lang="el-GR" sz="105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0" lang="en-US" sz="105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D04BE4A0-467D-4070-B64B-9F2C118EF847}"/>
                  </a:ext>
                </a:extLst>
              </p:cNvPr>
              <p:cNvSpPr txBox="1"/>
              <p:nvPr/>
            </p:nvSpPr>
            <p:spPr>
              <a:xfrm>
                <a:off x="5544041" y="4954125"/>
                <a:ext cx="847286" cy="2247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462915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5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Bispecific Ab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98515101-AB5F-4E78-A682-FFAEA0B99110}"/>
                  </a:ext>
                </a:extLst>
              </p:cNvPr>
              <p:cNvSpPr txBox="1"/>
              <p:nvPr/>
            </p:nvSpPr>
            <p:spPr>
              <a:xfrm>
                <a:off x="2980439" y="4954125"/>
                <a:ext cx="672778" cy="2247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462915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5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nti-</a:t>
                </a:r>
                <a:r>
                  <a:rPr kumimoji="0" lang="el-GR" sz="105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kumimoji="0" lang="en-US" sz="105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v</a:t>
                </a:r>
                <a:r>
                  <a:rPr kumimoji="0" lang="el-GR" sz="105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kumimoji="0" lang="en-US" sz="105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3F6D0F30-184D-40C5-AF9D-82030B65FD09}"/>
                  </a:ext>
                </a:extLst>
              </p:cNvPr>
              <p:cNvSpPr txBox="1"/>
              <p:nvPr/>
            </p:nvSpPr>
            <p:spPr>
              <a:xfrm rot="16200000">
                <a:off x="1242821" y="5637980"/>
                <a:ext cx="330856" cy="2315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289322">
                  <a:defRPr/>
                </a:pPr>
                <a:r>
                  <a:rPr lang="en-US" sz="110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N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8CB2C145-4003-477F-81BA-EEA2846A0D4F}"/>
                  </a:ext>
                </a:extLst>
              </p:cNvPr>
              <p:cNvSpPr txBox="1"/>
              <p:nvPr/>
            </p:nvSpPr>
            <p:spPr>
              <a:xfrm rot="16200000">
                <a:off x="1086758" y="6909776"/>
                <a:ext cx="642984" cy="2315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289322">
                  <a:defRPr/>
                </a:pPr>
                <a:r>
                  <a:rPr lang="en-US" sz="110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L1A1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5B67D640-44A5-4C40-8143-D52616D97BD9}"/>
                  </a:ext>
                </a:extLst>
              </p:cNvPr>
              <p:cNvSpPr txBox="1"/>
              <p:nvPr/>
            </p:nvSpPr>
            <p:spPr>
              <a:xfrm rot="16200000">
                <a:off x="1149893" y="8126409"/>
                <a:ext cx="516715" cy="2315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289322">
                  <a:defRPr/>
                </a:pPr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Merge</a:t>
                </a:r>
              </a:p>
            </p:txBody>
          </p:sp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A00FCE10-DC06-45D1-8A40-57BEFE3673A7}"/>
                  </a:ext>
                </a:extLst>
              </p:cNvPr>
              <p:cNvGrpSpPr/>
              <p:nvPr/>
            </p:nvGrpSpPr>
            <p:grpSpPr>
              <a:xfrm>
                <a:off x="5739312" y="8885202"/>
                <a:ext cx="766624" cy="204302"/>
                <a:chOff x="5512071" y="9470276"/>
                <a:chExt cx="766624" cy="204302"/>
              </a:xfrm>
            </p:grpSpPr>
            <p:cxnSp>
              <p:nvCxnSpPr>
                <p:cNvPr id="93" name="Straight Connector 92">
                  <a:extLst>
                    <a:ext uri="{FF2B5EF4-FFF2-40B4-BE49-F238E27FC236}">
                      <a16:creationId xmlns:a16="http://schemas.microsoft.com/office/drawing/2014/main" id="{DBB2319C-3D95-4D00-AFE1-D23979B8E56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976276" y="9572416"/>
                  <a:ext cx="30241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2650BDE5-AD2F-42F9-A372-1968EC006B7E}"/>
                    </a:ext>
                  </a:extLst>
                </p:cNvPr>
                <p:cNvSpPr txBox="1"/>
                <p:nvPr/>
              </p:nvSpPr>
              <p:spPr>
                <a:xfrm>
                  <a:off x="5512071" y="9470276"/>
                  <a:ext cx="521723" cy="20430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 µm</a:t>
                  </a:r>
                </a:p>
              </p:txBody>
            </p:sp>
          </p:grpSp>
        </p:grp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F85F01AF-E2FC-4A20-BC96-820C3267DBD5}"/>
              </a:ext>
            </a:extLst>
          </p:cNvPr>
          <p:cNvSpPr/>
          <p:nvPr/>
        </p:nvSpPr>
        <p:spPr>
          <a:xfrm>
            <a:off x="219015" y="137275"/>
            <a:ext cx="6451828" cy="15972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3:  Effect of </a:t>
            </a:r>
            <a:r>
              <a:rPr lang="el-GR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</a:t>
            </a:r>
            <a:r>
              <a:rPr lang="el-GR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/</a:t>
            </a:r>
            <a:r>
              <a:rPr lang="el-GR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α5β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 bispecific antibody on ECM assembly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1000" u="sng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  Actin staining to visualize cell cytoskeleton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F-1299 were incubated with control IgG vs. indicated antibodies for 72 hours, and then processed for immunostaining to examine FN and actin.  Images are representative of at least 3 independent experiments.</a:t>
            </a: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1000" u="sng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:  Cell-free ECM illustrates significant effect of antibody treatment on CAF-ECM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F-1299 were plated and allowed to produce ECM for 72 hours before cells were removed to leave behind a cell-free ECM, which was then prepared for immunofluorescence staining to detect FN and COL.  Images are representative of at least 3 independent experiments.</a:t>
            </a: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62483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2543e7ec-7072-4b75-829f-0ed03e19ff1e">
      <Terms xmlns="http://schemas.microsoft.com/office/infopath/2007/PartnerControls"/>
    </lcf76f155ced4ddcb4097134ff3c332f>
    <TaxCatchAll xmlns="57a0c4cc-3c09-49e8-920e-d8be8823b2ff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F3B51C6BCD074793790340586B5297" ma:contentTypeVersion="18" ma:contentTypeDescription="Create a new document." ma:contentTypeScope="" ma:versionID="d8e7e0b6111b9d67775a07373b940835">
  <xsd:schema xmlns:xsd="http://www.w3.org/2001/XMLSchema" xmlns:xs="http://www.w3.org/2001/XMLSchema" xmlns:p="http://schemas.microsoft.com/office/2006/metadata/properties" xmlns:ns2="57a0c4cc-3c09-49e8-920e-d8be8823b2ff" xmlns:ns3="2543e7ec-7072-4b75-829f-0ed03e19ff1e" targetNamespace="http://schemas.microsoft.com/office/2006/metadata/properties" ma:root="true" ma:fieldsID="26eab72f2527c02910f532a8625ffb45" ns2:_="" ns3:_="">
    <xsd:import namespace="57a0c4cc-3c09-49e8-920e-d8be8823b2ff"/>
    <xsd:import namespace="2543e7ec-7072-4b75-829f-0ed03e19ff1e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MediaServiceLocation" minOccurs="0"/>
                <xsd:element ref="ns3:lcf76f155ced4ddcb4097134ff3c332f" minOccurs="0"/>
                <xsd:element ref="ns2:TaxCatchAll" minOccurs="0"/>
                <xsd:element ref="ns3:MediaServiceObjectDetectorVersion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7a0c4cc-3c09-49e8-920e-d8be8823b2ff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bfe539f8-3b21-43ac-9575-bd53185d5a89}" ma:internalName="TaxCatchAll" ma:showField="CatchAllData" ma:web="57a0c4cc-3c09-49e8-920e-d8be8823b2ff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543e7ec-7072-4b75-829f-0ed03e19ff1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2ccd466c-82b6-42a3-8ba5-5c7db83406b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428AF018-5240-4F2F-B0A7-10A84DD9D26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8778B21-93DC-4DE6-9C7D-29A88DF3DBC8}">
  <ds:schemaRefs>
    <ds:schemaRef ds:uri="http://schemas.microsoft.com/office/2006/metadata/properties"/>
    <ds:schemaRef ds:uri="http://purl.org/dc/terms/"/>
    <ds:schemaRef ds:uri="http://schemas.microsoft.com/office/2006/documentManagement/types"/>
    <ds:schemaRef ds:uri="http://purl.org/dc/dcmitype/"/>
    <ds:schemaRef ds:uri="57a0c4cc-3c09-49e8-920e-d8be8823b2ff"/>
    <ds:schemaRef ds:uri="http://schemas.microsoft.com/office/infopath/2007/PartnerControls"/>
    <ds:schemaRef ds:uri="http://purl.org/dc/elements/1.1/"/>
    <ds:schemaRef ds:uri="http://schemas.openxmlformats.org/package/2006/metadata/core-properties"/>
    <ds:schemaRef ds:uri="2543e7ec-7072-4b75-829f-0ed03e19ff1e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B01E279D-CEC9-47C5-B8DD-CF8E61B016A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7a0c4cc-3c09-49e8-920e-d8be8823b2ff"/>
    <ds:schemaRef ds:uri="2543e7ec-7072-4b75-829f-0ed03e19ff1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1</TotalTime>
  <Words>164</Words>
  <Application>Microsoft Office PowerPoint</Application>
  <PresentationFormat>A4 Paper (210x297 mm)</PresentationFormat>
  <Paragraphs>2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, Chengsheng</dc:creator>
  <cp:lastModifiedBy>Weis, Sara</cp:lastModifiedBy>
  <cp:revision>20</cp:revision>
  <dcterms:created xsi:type="dcterms:W3CDTF">2024-03-19T17:07:22Z</dcterms:created>
  <dcterms:modified xsi:type="dcterms:W3CDTF">2025-01-02T17:22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F3B51C6BCD074793790340586B5297</vt:lpwstr>
  </property>
  <property fmtid="{D5CDD505-2E9C-101B-9397-08002B2CF9AE}" pid="3" name="MediaServiceImageTags">
    <vt:lpwstr/>
  </property>
</Properties>
</file>